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7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10BD19D2-B7F3-4734-9C14-499E31709C1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Underrubrik 2">
            <a:extLst>
              <a:ext uri="{FF2B5EF4-FFF2-40B4-BE49-F238E27FC236}">
                <a16:creationId xmlns:a16="http://schemas.microsoft.com/office/drawing/2014/main" id="{C5C559AA-9CC8-4215-861F-CF03F603783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v-SE"/>
              <a:t>Klicka här för att ändra mall för underrubrikformat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939BE09A-2A05-4CFE-AC30-4489EAD681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61F2BF-36B6-4D31-AD58-17F0F15754A0}" type="datetimeFigureOut">
              <a:rPr lang="sv-SE" smtClean="0"/>
              <a:t>2021-01-22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C3DA325B-81DD-4017-AD79-272301D8C2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4B1BB58E-5B72-4D2C-AB40-B3603FCD92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4160A-DDF3-469A-9A24-93F10C4FD50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1587738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93248504-1D0E-4E67-9F26-3ECF7CEC13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9E7809E7-A8AE-4BC8-97EC-6F6660B6287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C2E7A37F-039F-4698-9C47-A895BE6AA9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61F2BF-36B6-4D31-AD58-17F0F15754A0}" type="datetimeFigureOut">
              <a:rPr lang="sv-SE" smtClean="0"/>
              <a:t>2021-01-22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B4555063-E81F-4768-A386-DC37C21B67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1292C58F-AFA5-4FAE-AA7A-FB9662C933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4160A-DDF3-469A-9A24-93F10C4FD50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4355076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>
            <a:extLst>
              <a:ext uri="{FF2B5EF4-FFF2-40B4-BE49-F238E27FC236}">
                <a16:creationId xmlns:a16="http://schemas.microsoft.com/office/drawing/2014/main" id="{F1D38A50-77C5-4243-B10B-BF9E9B00B98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EF39E1B2-EF81-4DD5-8B9E-B557A4FCC9A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824E6BAD-C6C9-4756-B13B-04F69EA43D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61F2BF-36B6-4D31-AD58-17F0F15754A0}" type="datetimeFigureOut">
              <a:rPr lang="sv-SE" smtClean="0"/>
              <a:t>2021-01-22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F32E2FD0-E6EF-4F6C-9D41-D3308E48F4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E80CC429-D689-4582-8676-6F9EAA04AF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4160A-DDF3-469A-9A24-93F10C4FD50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860310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F56B1F3A-335C-4B9E-9DB3-59C41928CC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14F03ABC-4293-4C98-BC5A-5F3A533E503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206B00C4-E608-406C-A6D4-37D6A9D105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61F2BF-36B6-4D31-AD58-17F0F15754A0}" type="datetimeFigureOut">
              <a:rPr lang="sv-SE" smtClean="0"/>
              <a:t>2021-01-22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F8FC165E-4E32-4C78-B6C0-047D27EB57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BF12C5D8-398A-4D39-BE0D-380D5116DD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4160A-DDF3-469A-9A24-93F10C4FD50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1855097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2BCF0FBC-DCAA-41F1-8928-947EBB1199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A4F56D8E-44BD-4378-BA9D-1F8B994A67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15BF573D-36B0-4AE4-B420-D5CA593F35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61F2BF-36B6-4D31-AD58-17F0F15754A0}" type="datetimeFigureOut">
              <a:rPr lang="sv-SE" smtClean="0"/>
              <a:t>2021-01-22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87933B5E-CD2A-4F98-99CA-DA7E6016F8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92110F5A-7CDF-497D-B74A-D3E81F3B97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4160A-DDF3-469A-9A24-93F10C4FD50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1128162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EB44D76B-D20E-48E9-9AF5-E3A0BDC4D6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5542D4EF-F6C2-4F95-8DDE-18A22949EA3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9D70695B-DD7B-4A42-9792-FE4F1DE60A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B81A0A72-93D0-443A-ABAB-D298B589C2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61F2BF-36B6-4D31-AD58-17F0F15754A0}" type="datetimeFigureOut">
              <a:rPr lang="sv-SE" smtClean="0"/>
              <a:t>2021-01-22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BF84FBB2-EDDC-4CA4-AA6C-3EF427FCF9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C44B15E8-E6BE-4B88-A900-D928FA9F13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4160A-DDF3-469A-9A24-93F10C4FD50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934558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3E9453C2-AE71-4FE9-B8A7-190439EE46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1BEA49F7-AEC5-42FE-AA32-A28E9D845B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C068C0BC-3FB4-4380-AF95-EE2F8334601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text 4">
            <a:extLst>
              <a:ext uri="{FF2B5EF4-FFF2-40B4-BE49-F238E27FC236}">
                <a16:creationId xmlns:a16="http://schemas.microsoft.com/office/drawing/2014/main" id="{3950C672-11FB-416E-ACCE-83A5A2F5D54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6" name="Platshållare för innehåll 5">
            <a:extLst>
              <a:ext uri="{FF2B5EF4-FFF2-40B4-BE49-F238E27FC236}">
                <a16:creationId xmlns:a16="http://schemas.microsoft.com/office/drawing/2014/main" id="{1C5EB25E-BD21-442E-AEEF-3AC0402C926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7" name="Platshållare för datum 6">
            <a:extLst>
              <a:ext uri="{FF2B5EF4-FFF2-40B4-BE49-F238E27FC236}">
                <a16:creationId xmlns:a16="http://schemas.microsoft.com/office/drawing/2014/main" id="{1C2E0F17-4FFF-430B-B1B0-32E4F3F624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61F2BF-36B6-4D31-AD58-17F0F15754A0}" type="datetimeFigureOut">
              <a:rPr lang="sv-SE" smtClean="0"/>
              <a:t>2021-01-22</a:t>
            </a:fld>
            <a:endParaRPr lang="sv-SE"/>
          </a:p>
        </p:txBody>
      </p:sp>
      <p:sp>
        <p:nvSpPr>
          <p:cNvPr id="8" name="Platshållare för sidfot 7">
            <a:extLst>
              <a:ext uri="{FF2B5EF4-FFF2-40B4-BE49-F238E27FC236}">
                <a16:creationId xmlns:a16="http://schemas.microsoft.com/office/drawing/2014/main" id="{EFED8670-918A-4950-926F-F3CA3D979D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>
            <a:extLst>
              <a:ext uri="{FF2B5EF4-FFF2-40B4-BE49-F238E27FC236}">
                <a16:creationId xmlns:a16="http://schemas.microsoft.com/office/drawing/2014/main" id="{831F23B2-F477-4592-AF0B-D5BC5DDEF1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4160A-DDF3-469A-9A24-93F10C4FD50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5448449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701F674C-BB68-4B8B-8A17-C65644B2D5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datum 2">
            <a:extLst>
              <a:ext uri="{FF2B5EF4-FFF2-40B4-BE49-F238E27FC236}">
                <a16:creationId xmlns:a16="http://schemas.microsoft.com/office/drawing/2014/main" id="{86962931-3E23-4D15-8D14-3C4D21F597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61F2BF-36B6-4D31-AD58-17F0F15754A0}" type="datetimeFigureOut">
              <a:rPr lang="sv-SE" smtClean="0"/>
              <a:t>2021-01-22</a:t>
            </a:fld>
            <a:endParaRPr lang="sv-SE"/>
          </a:p>
        </p:txBody>
      </p:sp>
      <p:sp>
        <p:nvSpPr>
          <p:cNvPr id="4" name="Platshållare för sidfot 3">
            <a:extLst>
              <a:ext uri="{FF2B5EF4-FFF2-40B4-BE49-F238E27FC236}">
                <a16:creationId xmlns:a16="http://schemas.microsoft.com/office/drawing/2014/main" id="{6947DA4E-BB9E-4E6E-8171-E939EF281F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>
            <a:extLst>
              <a:ext uri="{FF2B5EF4-FFF2-40B4-BE49-F238E27FC236}">
                <a16:creationId xmlns:a16="http://schemas.microsoft.com/office/drawing/2014/main" id="{476315A6-6AE5-42CF-A640-FDB7826511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4160A-DDF3-469A-9A24-93F10C4FD50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5747267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>
            <a:extLst>
              <a:ext uri="{FF2B5EF4-FFF2-40B4-BE49-F238E27FC236}">
                <a16:creationId xmlns:a16="http://schemas.microsoft.com/office/drawing/2014/main" id="{9F3EEEE1-D69E-4A4F-B178-9F0A9E7EA6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61F2BF-36B6-4D31-AD58-17F0F15754A0}" type="datetimeFigureOut">
              <a:rPr lang="sv-SE" smtClean="0"/>
              <a:t>2021-01-22</a:t>
            </a:fld>
            <a:endParaRPr lang="sv-SE"/>
          </a:p>
        </p:txBody>
      </p:sp>
      <p:sp>
        <p:nvSpPr>
          <p:cNvPr id="3" name="Platshållare för sidfot 2">
            <a:extLst>
              <a:ext uri="{FF2B5EF4-FFF2-40B4-BE49-F238E27FC236}">
                <a16:creationId xmlns:a16="http://schemas.microsoft.com/office/drawing/2014/main" id="{3EE50C6A-4113-4460-A63F-6B2CAA5EC2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>
            <a:extLst>
              <a:ext uri="{FF2B5EF4-FFF2-40B4-BE49-F238E27FC236}">
                <a16:creationId xmlns:a16="http://schemas.microsoft.com/office/drawing/2014/main" id="{7B463BEC-FC58-41D3-9329-D77E7BE185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4160A-DDF3-469A-9A24-93F10C4FD50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287286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ext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7E7A62F3-91B1-4643-9940-AEA658A7D7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FF7B5FF6-8D67-42F6-8138-4CB4D2D11A8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744F503C-1197-47C7-80C0-6E8CE78CABC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5DA773A1-D766-4C5E-A90C-1C48E07212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61F2BF-36B6-4D31-AD58-17F0F15754A0}" type="datetimeFigureOut">
              <a:rPr lang="sv-SE" smtClean="0"/>
              <a:t>2021-01-22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59638B1A-6BD1-4646-920D-E5C1B24B3A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1000FFEA-F107-4B5B-A0EA-4C22D386E9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4160A-DDF3-469A-9A24-93F10C4FD50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8110463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4B1E09EA-CF42-4A4A-A37B-F663CFCD64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bild 2">
            <a:extLst>
              <a:ext uri="{FF2B5EF4-FFF2-40B4-BE49-F238E27FC236}">
                <a16:creationId xmlns:a16="http://schemas.microsoft.com/office/drawing/2014/main" id="{55A1CCFA-3F64-41B7-B435-110DFA41A82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CDBBC3F3-DE16-4CFA-9CEF-D61C48EE62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CC5DD500-35C3-4BB8-8CD4-49344FC8B5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61F2BF-36B6-4D31-AD58-17F0F15754A0}" type="datetimeFigureOut">
              <a:rPr lang="sv-SE" smtClean="0"/>
              <a:t>2021-01-22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D22CE26C-FD50-4BFC-BC02-864D2F0C80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4DAE8446-FEB2-4577-A88E-AA5F71D7A8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B4160A-DDF3-469A-9A24-93F10C4FD50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6642887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>
            <a:extLst>
              <a:ext uri="{FF2B5EF4-FFF2-40B4-BE49-F238E27FC236}">
                <a16:creationId xmlns:a16="http://schemas.microsoft.com/office/drawing/2014/main" id="{059C7863-8EEE-4990-83EC-1C3EFEDA8C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9335145F-1914-46ED-B5F5-BCA04ABF5F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21328A80-6F1D-47F5-A925-11039B1CEB2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61F2BF-36B6-4D31-AD58-17F0F15754A0}" type="datetimeFigureOut">
              <a:rPr lang="sv-SE" smtClean="0"/>
              <a:t>2021-01-22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F74F6D88-4B53-473B-B300-801D9E246E9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FBD21788-8B1F-4DF9-B066-08CFB809667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B4160A-DDF3-469A-9A24-93F10C4FD50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7301937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Bildobjekt 2" descr="En bild som visar text&#10;&#10;Automatiskt genererad beskrivning">
            <a:extLst>
              <a:ext uri="{FF2B5EF4-FFF2-40B4-BE49-F238E27FC236}">
                <a16:creationId xmlns:a16="http://schemas.microsoft.com/office/drawing/2014/main" id="{2F2CEA46-B682-4ED2-8F89-A65BF2E89E5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91365" y="823796"/>
            <a:ext cx="2902722" cy="2505559"/>
          </a:xfrm>
          <a:prstGeom prst="rect">
            <a:avLst/>
          </a:prstGeom>
        </p:spPr>
      </p:pic>
      <p:pic>
        <p:nvPicPr>
          <p:cNvPr id="5" name="Bildobjekt 4">
            <a:extLst>
              <a:ext uri="{FF2B5EF4-FFF2-40B4-BE49-F238E27FC236}">
                <a16:creationId xmlns:a16="http://schemas.microsoft.com/office/drawing/2014/main" id="{07D91F45-A192-4182-B5C1-19EC59FBC5E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36850" y="823796"/>
            <a:ext cx="3033638" cy="2505560"/>
          </a:xfrm>
          <a:prstGeom prst="rect">
            <a:avLst/>
          </a:prstGeom>
        </p:spPr>
      </p:pic>
      <p:pic>
        <p:nvPicPr>
          <p:cNvPr id="7" name="Bildobjekt 6" descr="En bild som visar text&#10;&#10;Automatiskt genererad beskrivning">
            <a:extLst>
              <a:ext uri="{FF2B5EF4-FFF2-40B4-BE49-F238E27FC236}">
                <a16:creationId xmlns:a16="http://schemas.microsoft.com/office/drawing/2014/main" id="{0DA472BE-7525-4988-8F73-B0B7C89E48A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91365" y="3364349"/>
            <a:ext cx="2901257" cy="2260520"/>
          </a:xfrm>
          <a:prstGeom prst="rect">
            <a:avLst/>
          </a:prstGeom>
        </p:spPr>
      </p:pic>
      <p:pic>
        <p:nvPicPr>
          <p:cNvPr id="9" name="Bildobjekt 8" descr="En bild som visar inomhus&#10;&#10;Automatiskt genererad beskrivning">
            <a:extLst>
              <a:ext uri="{FF2B5EF4-FFF2-40B4-BE49-F238E27FC236}">
                <a16:creationId xmlns:a16="http://schemas.microsoft.com/office/drawing/2014/main" id="{6A166ECF-F9A3-4A1D-9FB8-BF36911B2A77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198"/>
          <a:stretch/>
        </p:blipFill>
        <p:spPr>
          <a:xfrm>
            <a:off x="6036850" y="3362591"/>
            <a:ext cx="3033638" cy="2268000"/>
          </a:xfrm>
          <a:prstGeom prst="rect">
            <a:avLst/>
          </a:prstGeom>
        </p:spPr>
      </p:pic>
      <p:sp>
        <p:nvSpPr>
          <p:cNvPr id="10" name="textruta 9">
            <a:extLst>
              <a:ext uri="{FF2B5EF4-FFF2-40B4-BE49-F238E27FC236}">
                <a16:creationId xmlns:a16="http://schemas.microsoft.com/office/drawing/2014/main" id="{DDCCE73D-2A60-4D9A-8B68-45773606EEFB}"/>
              </a:ext>
            </a:extLst>
          </p:cNvPr>
          <p:cNvSpPr txBox="1"/>
          <p:nvPr/>
        </p:nvSpPr>
        <p:spPr>
          <a:xfrm>
            <a:off x="3028426" y="5655816"/>
            <a:ext cx="610718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b="1"/>
              <a:t>Supplementary Figure S1</a:t>
            </a:r>
            <a:r>
              <a:rPr lang="sv-SE" sz="1200"/>
              <a:t>. Regions of special interest: along inferior epigastric vessels, </a:t>
            </a:r>
            <a:r>
              <a:rPr lang="sv-SE" sz="1200" i="1"/>
              <a:t>red</a:t>
            </a:r>
            <a:r>
              <a:rPr lang="sv-SE" sz="1200"/>
              <a:t>; along internal pudendal vessels lateral to the sacrospinous ligament, </a:t>
            </a:r>
            <a:r>
              <a:rPr lang="sv-SE" sz="1200" i="1"/>
              <a:t>green</a:t>
            </a:r>
            <a:r>
              <a:rPr lang="sv-SE" sz="1200"/>
              <a:t>; ischiorectal fossa, </a:t>
            </a:r>
            <a:r>
              <a:rPr lang="sv-SE" sz="1200" i="1"/>
              <a:t>organge</a:t>
            </a:r>
            <a:r>
              <a:rPr lang="sv-SE" sz="1200"/>
              <a:t>; ano-inguinal lymphatic drainage, </a:t>
            </a:r>
            <a:r>
              <a:rPr lang="sv-SE" sz="1200" i="1"/>
              <a:t>yellow</a:t>
            </a:r>
            <a:r>
              <a:rPr lang="sv-SE" sz="1200"/>
              <a:t>; poserolateral to deep inguinal vessels, </a:t>
            </a:r>
            <a:r>
              <a:rPr lang="sv-SE" sz="1200" i="1"/>
              <a:t>blue</a:t>
            </a:r>
            <a:r>
              <a:rPr lang="sv-SE" sz="120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16137558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7</Words>
  <Application>Microsoft Office PowerPoint</Application>
  <PresentationFormat>Bredbild</PresentationFormat>
  <Paragraphs>1</Paragraphs>
  <Slides>1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3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ema</vt:lpstr>
      <vt:lpstr>PowerPoint-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Nilsson Martin P</dc:creator>
  <cp:lastModifiedBy>Nilsson Martin P</cp:lastModifiedBy>
  <cp:revision>3</cp:revision>
  <dcterms:created xsi:type="dcterms:W3CDTF">2021-01-22T08:02:31Z</dcterms:created>
  <dcterms:modified xsi:type="dcterms:W3CDTF">2021-01-22T08:21:25Z</dcterms:modified>
</cp:coreProperties>
</file>